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D5B04C-C761-4AAB-AF84-59E1195D6D4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0C4DFD-A40B-4515-9789-E5AF9435481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778139-AC8A-4054-BFAD-97509A8E4D4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587BC8-8FF8-4585-B4B6-BBE50E0091A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00FC79-CD6F-46A4-AD94-AC3704BAB6A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8BA100-D645-45C6-9792-9CB762F7AC5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4AE726-52B8-467C-B463-DD828560AD6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DDFE19-4E95-489D-BBEA-3019EE3710A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D61053-0BBE-4749-B721-8DF81077788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04AABA-94CD-469D-829E-15A7748735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DC37B4-DC62-47D1-B456-18CF0F10EC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E24A3A-C8F3-43BA-9354-D4B4E99248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D20B434-E239-4F31-B9DD-220A2CDC0980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6DBCCB7-5DC9-4B62-8754-F6AEFCB4C5E7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Chart 4" descr=""/>
          <p:cNvPicPr/>
          <p:nvPr/>
        </p:nvPicPr>
        <p:blipFill>
          <a:blip r:embed="rId1"/>
          <a:stretch/>
        </p:blipFill>
        <p:spPr>
          <a:xfrm>
            <a:off x="682560" y="706320"/>
            <a:ext cx="7321680" cy="3444840"/>
          </a:xfrm>
          <a:prstGeom prst="rect">
            <a:avLst/>
          </a:prstGeom>
          <a:ln w="0">
            <a:noFill/>
          </a:ln>
        </p:spPr>
      </p:pic>
      <p:sp>
        <p:nvSpPr>
          <p:cNvPr id="42" name="TextBox 5"/>
          <p:cNvSpPr/>
          <p:nvPr/>
        </p:nvSpPr>
        <p:spPr>
          <a:xfrm rot="16200000">
            <a:off x="643320" y="4382640"/>
            <a:ext cx="1371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1.04  phosphate metabolis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6"/>
          <p:cNvSpPr/>
          <p:nvPr/>
        </p:nvSpPr>
        <p:spPr>
          <a:xfrm rot="16200000">
            <a:off x="841680" y="4191840"/>
            <a:ext cx="1752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1.05.02 sugar, glucoside, polyol and carboxylate metabolis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7"/>
          <p:cNvSpPr/>
          <p:nvPr/>
        </p:nvSpPr>
        <p:spPr>
          <a:xfrm rot="16200000">
            <a:off x="1298880" y="4245840"/>
            <a:ext cx="164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1.06 lipid, fatty acid and isoprenoid metabolis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8"/>
          <p:cNvSpPr/>
          <p:nvPr/>
        </p:nvSpPr>
        <p:spPr>
          <a:xfrm rot="16200000">
            <a:off x="5693040" y="4245840"/>
            <a:ext cx="164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2 Biogenesis of cellular component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9"/>
          <p:cNvSpPr/>
          <p:nvPr/>
        </p:nvSpPr>
        <p:spPr>
          <a:xfrm rot="16200000">
            <a:off x="2408400" y="4154040"/>
            <a:ext cx="1828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4 Protein fate (folding, modification, destination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10"/>
          <p:cNvSpPr/>
          <p:nvPr/>
        </p:nvSpPr>
        <p:spPr>
          <a:xfrm rot="16200000">
            <a:off x="2853000" y="4268160"/>
            <a:ext cx="1600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6 Protein with binding function or cofactor requirement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11"/>
          <p:cNvSpPr/>
          <p:nvPr/>
        </p:nvSpPr>
        <p:spPr>
          <a:xfrm rot="16200000">
            <a:off x="3357720" y="4306320"/>
            <a:ext cx="1524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8 Regulation of metabolism and protein func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12"/>
          <p:cNvSpPr/>
          <p:nvPr/>
        </p:nvSpPr>
        <p:spPr>
          <a:xfrm rot="16200000">
            <a:off x="3742200" y="4245480"/>
            <a:ext cx="15242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0 Cellular transport, transport facilities and transport route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3"/>
          <p:cNvSpPr/>
          <p:nvPr/>
        </p:nvSpPr>
        <p:spPr>
          <a:xfrm rot="16200000">
            <a:off x="4147200" y="4245480"/>
            <a:ext cx="15242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0 Cellular communication/signal transduction mechanis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4"/>
          <p:cNvSpPr/>
          <p:nvPr/>
        </p:nvSpPr>
        <p:spPr>
          <a:xfrm rot="16200000">
            <a:off x="4167000" y="3986280"/>
            <a:ext cx="2286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2 Cell rescue, defense and virulenc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15"/>
          <p:cNvSpPr/>
          <p:nvPr/>
        </p:nvSpPr>
        <p:spPr>
          <a:xfrm rot="16200000">
            <a:off x="4723920" y="4138560"/>
            <a:ext cx="1981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4 Interaction with the  environmen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16"/>
          <p:cNvSpPr/>
          <p:nvPr/>
        </p:nvSpPr>
        <p:spPr>
          <a:xfrm rot="16200000">
            <a:off x="5296320" y="4245840"/>
            <a:ext cx="164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6 Systemic interaction with the environmen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17"/>
          <p:cNvSpPr/>
          <p:nvPr/>
        </p:nvSpPr>
        <p:spPr>
          <a:xfrm rot="16200000">
            <a:off x="6043320" y="4268880"/>
            <a:ext cx="1720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70.01 cell wal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18"/>
          <p:cNvSpPr/>
          <p:nvPr/>
        </p:nvSpPr>
        <p:spPr>
          <a:xfrm rot="16200000">
            <a:off x="6436080" y="4191840"/>
            <a:ext cx="1752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70.02 eukaryotic plasma membrane / membrane attache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19"/>
          <p:cNvSpPr/>
          <p:nvPr/>
        </p:nvSpPr>
        <p:spPr>
          <a:xfrm rot="16200000">
            <a:off x="1697400" y="4245840"/>
            <a:ext cx="164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0 Cell cycle and DNA processin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20"/>
          <p:cNvSpPr/>
          <p:nvPr/>
        </p:nvSpPr>
        <p:spPr>
          <a:xfrm rot="16200000">
            <a:off x="2097000" y="4306680"/>
            <a:ext cx="1644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1 Transcrip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21"/>
          <p:cNvSpPr/>
          <p:nvPr/>
        </p:nvSpPr>
        <p:spPr>
          <a:xfrm rot="16200000">
            <a:off x="6856200" y="4268880"/>
            <a:ext cx="1720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70.04 cytoskelet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9" name="Group 28"/>
          <p:cNvGrpSpPr/>
          <p:nvPr/>
        </p:nvGrpSpPr>
        <p:grpSpPr>
          <a:xfrm>
            <a:off x="5143680" y="5125680"/>
            <a:ext cx="1638000" cy="541800"/>
            <a:chOff x="5143680" y="5125680"/>
            <a:chExt cx="1638000" cy="541800"/>
          </a:xfrm>
        </p:grpSpPr>
        <p:sp>
          <p:nvSpPr>
            <p:cNvPr id="60" name="TextBox 24"/>
            <p:cNvSpPr/>
            <p:nvPr/>
          </p:nvSpPr>
          <p:spPr>
            <a:xfrm>
              <a:off x="5207400" y="5421240"/>
              <a:ext cx="1478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Response to Stres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eft Brace 27"/>
            <p:cNvSpPr/>
            <p:nvPr/>
          </p:nvSpPr>
          <p:spPr>
            <a:xfrm rot="16200000">
              <a:off x="5790960" y="4478040"/>
              <a:ext cx="343080" cy="1638000"/>
            </a:xfrm>
            <a:custGeom>
              <a:avLst/>
              <a:gdLst>
                <a:gd name="textAreaLeft" fmla="*/ 219240 w 343080"/>
                <a:gd name="textAreaRight" fmla="*/ 343440 w 343080"/>
                <a:gd name="textAreaTop" fmla="*/ 8640 h 1638000"/>
                <a:gd name="textAreaBottom" fmla="*/ 1629360 h 163800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189"/>
                    <a:pt x="10800" y="377"/>
                  </a:cubicBezTo>
                  <a:lnTo>
                    <a:pt x="10800" y="10423"/>
                  </a:lnTo>
                  <a:cubicBezTo>
                    <a:pt x="10800" y="10612"/>
                    <a:pt x="5400" y="10800"/>
                    <a:pt x="0" y="10800"/>
                  </a:cubicBezTo>
                  <a:cubicBezTo>
                    <a:pt x="5400" y="10800"/>
                    <a:pt x="10800" y="10989"/>
                    <a:pt x="10800" y="11177"/>
                  </a:cubicBezTo>
                  <a:lnTo>
                    <a:pt x="10800" y="21223"/>
                  </a:lnTo>
                  <a:cubicBezTo>
                    <a:pt x="10800" y="21412"/>
                    <a:pt x="16200" y="21600"/>
                    <a:pt x="2160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2" name="TextBox 25"/>
          <p:cNvSpPr/>
          <p:nvPr/>
        </p:nvSpPr>
        <p:spPr>
          <a:xfrm>
            <a:off x="533520" y="5830920"/>
            <a:ext cx="81532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ditional file 2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unctional classification of differentially expressed transcripts during fibre developmental stages in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fl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mutant as compared to their respective stages in WT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G. hirsutum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L. cv. MCU5) based on MIPS data base.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-5 represents the 0, 5, 10, 15 and 20 dpa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70"/>
          <p:cNvSpPr/>
          <p:nvPr/>
        </p:nvSpPr>
        <p:spPr>
          <a:xfrm>
            <a:off x="228600" y="152280"/>
            <a:ext cx="2495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admalatha et al., Additional file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8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HP</dc:creator>
  <dc:description/>
  <dc:language>en-US</dc:language>
  <cp:lastModifiedBy>Dr. V Siva Reddy</cp:lastModifiedBy>
  <dcterms:modified xsi:type="dcterms:W3CDTF">2012-10-08T20:57:53Z</dcterms:modified>
  <cp:revision>133</cp:revision>
  <dc:subject/>
  <dc:title>Slide 1</dc:title>
</cp:coreProperties>
</file>